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20" d="100"/>
          <a:sy n="120" d="100"/>
        </p:scale>
        <p:origin x="-2430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DBEC10-AD18-4495-BB41-D30052D54A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B0922C-1115-4016-9139-A67DA2B3055A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76275" y="2016125"/>
            <a:ext cx="5503863" cy="51101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Retângulo 4"/>
          <p:cNvSpPr/>
          <p:nvPr/>
        </p:nvSpPr>
        <p:spPr>
          <a:xfrm>
            <a:off x="357190" y="1559462"/>
            <a:ext cx="635795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 smtClean="0"/>
              <a:t>modified </a:t>
            </a:r>
            <a:r>
              <a:rPr lang="en-US" b="1" dirty="0"/>
              <a:t>Bristol Stool Form Scale for Children – </a:t>
            </a:r>
            <a:r>
              <a:rPr lang="en-US" b="1" dirty="0" smtClean="0"/>
              <a:t>m-BSFS-C </a:t>
            </a:r>
            <a:endParaRPr lang="pt-BR" dirty="0"/>
          </a:p>
        </p:txBody>
      </p:sp>
      <p:sp>
        <p:nvSpPr>
          <p:cNvPr id="1027" name="Rectangle 3"/>
          <p:cNvSpPr>
            <a:spLocks noChangeArrowheads="1"/>
          </p:cNvSpPr>
          <p:nvPr/>
        </p:nvSpPr>
        <p:spPr bwMode="auto">
          <a:xfrm>
            <a:off x="500066" y="7215206"/>
            <a:ext cx="6000768" cy="18466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Char char="-"/>
              <a:tabLst/>
            </a:pPr>
            <a:r>
              <a:rPr kumimoji="0" lang="en-GB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humpitazi</a:t>
            </a:r>
            <a:r>
              <a:rPr kumimoji="0" lang="en-GB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BP, Lane MM, </a:t>
            </a:r>
            <a:r>
              <a:rPr kumimoji="0" lang="en-GB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zyzewski</a:t>
            </a:r>
            <a:r>
              <a:rPr kumimoji="0" lang="en-GB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DI, </a:t>
            </a:r>
            <a:r>
              <a:rPr kumimoji="0" lang="en-GB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Weidler</a:t>
            </a:r>
            <a:r>
              <a:rPr kumimoji="0" lang="en-GB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EM, Swank PR, </a:t>
            </a:r>
            <a:r>
              <a:rPr kumimoji="0" lang="en-GB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hulman</a:t>
            </a:r>
            <a:r>
              <a:rPr kumimoji="0" lang="en-GB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RJ. Creation and initial evaluation of a stool form scale for children. J </a:t>
            </a:r>
            <a:r>
              <a:rPr kumimoji="0" lang="en-GB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ediatr</a:t>
            </a:r>
            <a:r>
              <a:rPr kumimoji="0" lang="en-GB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 2010;157: 594-597.</a:t>
            </a:r>
          </a:p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endParaRPr kumimoji="0" lang="en-GB" sz="11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Char char="-"/>
              <a:tabLst/>
            </a:pPr>
            <a:endParaRPr kumimoji="0" lang="pt-B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Char char="-"/>
              <a:tabLst/>
            </a:pPr>
            <a:r>
              <a:rPr kumimoji="0" lang="en-GB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Lane MM, </a:t>
            </a:r>
            <a:r>
              <a:rPr kumimoji="0" lang="en-GB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zyzewski</a:t>
            </a:r>
            <a:r>
              <a:rPr kumimoji="0" lang="en-GB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DI, </a:t>
            </a:r>
            <a:r>
              <a:rPr kumimoji="0" lang="en-GB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humpitazi</a:t>
            </a:r>
            <a:r>
              <a:rPr kumimoji="0" lang="en-GB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BP, </a:t>
            </a:r>
            <a:r>
              <a:rPr kumimoji="0" lang="en-GB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hulman</a:t>
            </a:r>
            <a:r>
              <a:rPr kumimoji="0" lang="en-GB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RJ. Reliability and validity of a modified Bristol Stool Form Scale for children. J </a:t>
            </a:r>
            <a:r>
              <a:rPr kumimoji="0" lang="en-GB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ediatr</a:t>
            </a:r>
            <a:r>
              <a:rPr kumimoji="0" lang="en-GB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 2011;159:437-441.</a:t>
            </a:r>
            <a:endParaRPr lang="en-GB" sz="1100" dirty="0" smtClean="0">
              <a:solidFill>
                <a:srgbClr val="000000"/>
              </a:solidFill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endParaRPr kumimoji="0" lang="en-GB" sz="11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  <a:buFontTx/>
              <a:buChar char="-"/>
            </a:pPr>
            <a:r>
              <a:rPr lang="en-GB" sz="1100" dirty="0" err="1" smtClean="0">
                <a:latin typeface="Times New Roman" pitchFamily="18" charset="0"/>
                <a:cs typeface="Times New Roman" pitchFamily="18" charset="0"/>
              </a:rPr>
              <a:t>Jozala</a:t>
            </a:r>
            <a:r>
              <a:rPr lang="en-GB" sz="1100" dirty="0" smtClean="0">
                <a:latin typeface="Times New Roman" pitchFamily="18" charset="0"/>
                <a:cs typeface="Times New Roman" pitchFamily="18" charset="0"/>
              </a:rPr>
              <a:t> DR, Oliveira ISF, Ortolan EVP, Oliveira Junior WE, Comes GT, </a:t>
            </a:r>
            <a:r>
              <a:rPr lang="en-GB" sz="1100" dirty="0" err="1" smtClean="0">
                <a:latin typeface="Times New Roman" pitchFamily="18" charset="0"/>
                <a:cs typeface="Times New Roman" pitchFamily="18" charset="0"/>
              </a:rPr>
              <a:t>Cassettari</a:t>
            </a:r>
            <a:r>
              <a:rPr lang="en-GB" sz="1100" dirty="0" smtClean="0">
                <a:latin typeface="Times New Roman" pitchFamily="18" charset="0"/>
                <a:cs typeface="Times New Roman" pitchFamily="18" charset="0"/>
              </a:rPr>
              <a:t> VMG, Self MM, Lourenção PLTA. Brazilian Portuguese translation, cross-cultural adaptation and reproducibility assessment of the modified Bristol Stool Form Scale for children. J </a:t>
            </a:r>
            <a:r>
              <a:rPr lang="en-GB" sz="1100" dirty="0" err="1" smtClean="0">
                <a:latin typeface="Times New Roman" pitchFamily="18" charset="0"/>
                <a:cs typeface="Times New Roman" pitchFamily="18" charset="0"/>
              </a:rPr>
              <a:t>Pediatr</a:t>
            </a:r>
            <a:r>
              <a:rPr lang="en-GB" sz="1100" dirty="0" smtClean="0">
                <a:latin typeface="Times New Roman" pitchFamily="18" charset="0"/>
                <a:cs typeface="Times New Roman" pitchFamily="18" charset="0"/>
              </a:rPr>
              <a:t> (Rio J). 2019 May-Jun;95(3):321-327.</a:t>
            </a:r>
            <a:endParaRPr kumimoji="0" lang="en-GB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 Box 3"/>
          <p:cNvSpPr txBox="1">
            <a:spLocks noChangeArrowheads="1"/>
          </p:cNvSpPr>
          <p:nvPr/>
        </p:nvSpPr>
        <p:spPr bwMode="auto">
          <a:xfrm>
            <a:off x="2565400" y="184150"/>
            <a:ext cx="4298950" cy="325438"/>
          </a:xfrm>
          <a:prstGeom prst="rect">
            <a:avLst/>
          </a:prstGeom>
          <a:solidFill>
            <a:srgbClr val="FFFFFF"/>
          </a:solidFill>
          <a:ln w="9525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just" fontAlgn="base">
              <a:spcBef>
                <a:spcPct val="0"/>
              </a:spcBef>
              <a:spcAft>
                <a:spcPts val="1000"/>
              </a:spcAft>
            </a:pP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Coelho et al. A protocol for an interventional study on the impact of </a:t>
            </a:r>
            <a:r>
              <a:rPr lang="en-US" sz="700" dirty="0" err="1" smtClean="0">
                <a:latin typeface="Times New Roman" pitchFamily="18" charset="0"/>
                <a:cs typeface="Arial" pitchFamily="34" charset="0"/>
              </a:rPr>
              <a:t>transcutaneous</a:t>
            </a: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 </a:t>
            </a:r>
            <a:r>
              <a:rPr lang="en-US" sz="700" dirty="0" err="1" smtClean="0">
                <a:latin typeface="Times New Roman" pitchFamily="18" charset="0"/>
                <a:cs typeface="Arial" pitchFamily="34" charset="0"/>
              </a:rPr>
              <a:t>parasacral</a:t>
            </a: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 nerve stimulation in children with functional constipation.</a:t>
            </a:r>
          </a:p>
          <a:p>
            <a:pPr algn="just" fontAlgn="base">
              <a:spcBef>
                <a:spcPct val="0"/>
              </a:spcBef>
              <a:spcAft>
                <a:spcPts val="1000"/>
              </a:spcAft>
            </a:pP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. </a:t>
            </a:r>
          </a:p>
          <a:p>
            <a:pPr algn="just" fontAlgn="base">
              <a:spcBef>
                <a:spcPct val="0"/>
              </a:spcBef>
              <a:spcAft>
                <a:spcPts val="1000"/>
              </a:spcAft>
            </a:pP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Retângulo 7"/>
          <p:cNvSpPr/>
          <p:nvPr/>
        </p:nvSpPr>
        <p:spPr>
          <a:xfrm>
            <a:off x="2143116" y="714348"/>
            <a:ext cx="281359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Supplemental Digital Content </a:t>
            </a:r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 - </a:t>
            </a:r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5</a:t>
            </a:r>
            <a:endParaRPr lang="pt-BR" sz="1600" b="1" dirty="0">
              <a:solidFill>
                <a:srgbClr val="C00000"/>
              </a:solidFill>
              <a:latin typeface="Arial Narrow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61</Words>
  <Application>Microsoft Office PowerPoint</Application>
  <PresentationFormat>Apresentação na tela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edro</dc:creator>
  <cp:lastModifiedBy>Pedro</cp:lastModifiedBy>
  <cp:revision>8</cp:revision>
  <dcterms:created xsi:type="dcterms:W3CDTF">2017-03-22T11:14:29Z</dcterms:created>
  <dcterms:modified xsi:type="dcterms:W3CDTF">2020-10-08T17:47:02Z</dcterms:modified>
</cp:coreProperties>
</file>